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51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86" d="100"/>
          <a:sy n="86" d="100"/>
        </p:scale>
        <p:origin x="120" y="6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591B6E-DD85-76F5-572D-5B283F611AE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0F97B54-B01C-F307-92B0-45FE54A302C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0C5D81-BE07-67FC-2412-361DF9F95F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616F01-3548-29AB-F0F8-9A1FDDCF77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36AA3C-E054-AC18-C6A8-97E162B4A0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96502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E470E5-35EB-A23A-2079-BB9871CDAF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C6362F4-D07B-1E1F-0961-5B36A78C19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1DB674-5B17-DD21-E71E-1E23E6FCC6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0775AD-5139-1CC2-AEEE-C7274F615B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FB8E08-27DA-4AF6-1F0A-387854ACBB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8522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FCE7323-38EA-D133-4522-CAB0A60EF48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6B51A9B-4906-BAC8-5169-9C71FC2EB9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CF110F-2C3C-8FC7-F4F8-A43226068B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4BA0F0-1AAC-1D6D-E001-A5A21194D6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8FF68D-5A61-9352-0335-87C1A6761C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3293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14FF59-D2FC-1A00-53D8-76A301DF1E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B05ED88-C146-71E4-D52B-8A82D42D179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1300F5-F703-297B-FF23-5DC3EE62AA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C5522F-2E8A-C27A-513D-EF13B12F34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E3E46C-71B7-3B86-1E1F-BF18FC584C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04174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67590A-469A-54E1-15FE-C4DB0324F4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A44BB84-F999-7B0C-2227-43FAD38FF3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EFFED6-3544-5224-8696-91BA07BBB3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1C4F66-8158-9CBB-61FA-EB7B13DC40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998BF8-2F7C-E9EE-6DF9-2EF54F1E9D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80122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3A97D0-45D6-CD76-511D-A234E84807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0BC010-D56B-1D68-89FA-062F874BA8A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27F600-0533-19EE-47B9-C4BA6369C7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72539F1-605E-EE35-73DD-09D18ED8AA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4119D70-99CF-51DB-CE9D-9C8C7E5646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DA7AC8-40BF-3057-C590-18BE2C4128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087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213718-4BA8-D322-FF13-98AA9A9E54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535FE9-5C4B-17D7-BB59-A961C5EE7F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16250D9-6D6A-E6E5-471C-8002643ECC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943EF32-884B-EF2E-0979-42C0118DCE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7354C19-30FA-41EB-3C5C-6E4EED48544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B429C22-7D79-733B-9F9F-4EFE47ABFF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661135C-861B-AED4-E692-8020D4785C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BFCED44-FC99-C913-0FA5-85F87B8B5A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37704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6654DB-71D3-C547-4BA8-E0F93B3AEB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DDD4700-575A-9FB4-51DF-AFADC4602C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F4AFD67-5E06-90F9-5329-47574129B6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DBEF4F3-6800-CE73-182B-2858396C34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1438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E581F51-4A85-AF76-7BC1-DE09A2DB2B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9EE7159-7E52-C584-D711-53A768BDD4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5CD1CC9-67EB-96A5-E90C-762130DFEE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60073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D631AF-32FB-F978-CD96-50E0B0E041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B1ED3B-01F5-CC44-95B6-1A15E1BC4CC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25EE9F9-6317-FC5F-538C-3ADF09AA73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8B52E2-379D-08BB-4BD0-66F920E03D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14F40B-2543-765E-DC0B-F82B19D46B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22EB29-FC5F-C9FD-F09E-97A2D04FDE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11681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874128-E041-D9EA-D695-63D135E571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BFCE3E4-9E9A-02F4-7967-ACFB507F9EF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C12CA2C-E588-0949-E3D4-B06EC90D33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E2FB69B-B3DA-0F22-B4F0-0976230EC2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BE11B9-7675-7A9A-A892-97CA47F4E1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2ADA8A-C690-6BC5-238F-81BF6D77D4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48729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A288017-75BD-C380-5C1F-6C0260E0AE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344FACF-2A33-D139-4804-40BB926BD7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5004FB-6988-09C4-218D-923AC21E201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9BBA40-421C-259A-884B-22367F06A1F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740E4E-11A4-F140-7277-1E982CA26FA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3649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hyperlink" Target="http://www.ncbi.nlm.nih.gov/geo/query/acc.cgi?acc=GSE3292" TargetMode="Externa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0F257217-E543-468C-9AA0-294799A22D7E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7661" y="0"/>
            <a:ext cx="3993714" cy="3429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4BBE1FB9-0C12-4F03-AA38-0F124220BFC7}"/>
              </a:ext>
            </a:extLst>
          </p:cNvPr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71375" y="0"/>
            <a:ext cx="3993714" cy="3429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C686969-DCD2-48E7-8FC8-F6A47F8AC06C}"/>
              </a:ext>
            </a:extLst>
          </p:cNvPr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99559" y="3346798"/>
            <a:ext cx="3471798" cy="3322529"/>
          </a:xfrm>
          <a:prstGeom prst="rect">
            <a:avLst/>
          </a:prstGeom>
          <a:noFill/>
          <a:ln>
            <a:noFill/>
          </a:ln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D9CE33D1-C279-40B8-A4C7-BF18D36E05B9}"/>
              </a:ext>
            </a:extLst>
          </p:cNvPr>
          <p:cNvPicPr/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28796" y="3303740"/>
            <a:ext cx="3858016" cy="3554260"/>
          </a:xfrm>
          <a:prstGeom prst="rect">
            <a:avLst/>
          </a:prstGeom>
          <a:noFill/>
          <a:ln>
            <a:noFill/>
          </a:ln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id="{D47E9624-CF6D-4F17-8980-E2488EECA8EE}"/>
              </a:ext>
            </a:extLst>
          </p:cNvPr>
          <p:cNvSpPr/>
          <p:nvPr/>
        </p:nvSpPr>
        <p:spPr>
          <a:xfrm>
            <a:off x="3180567" y="6587124"/>
            <a:ext cx="8749429" cy="3112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400" b="1" dirty="0">
                <a:solidFill>
                  <a:srgbClr val="333333"/>
                </a:solidFill>
                <a:latin typeface="Helvetica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ccession: </a:t>
            </a:r>
            <a:r>
              <a:rPr lang="en-US" sz="1400" b="1" u="sng" dirty="0">
                <a:solidFill>
                  <a:srgbClr val="0088CC"/>
                </a:solidFill>
                <a:latin typeface="Helvetica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  <a:hlinkClick r:id="rId6"/>
              </a:rPr>
              <a:t>GSE3292</a:t>
            </a:r>
            <a:r>
              <a:rPr lang="en-US" sz="1400" b="1" dirty="0">
                <a:solidFill>
                  <a:srgbClr val="333333"/>
                </a:solidFill>
                <a:latin typeface="Helvetica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(opens in new browser window/tab) HNSCC, No. patients (OS/DSS): 32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3AE39E3F-7520-4E72-8F5C-35EF21F131C0}"/>
              </a:ext>
            </a:extLst>
          </p:cNvPr>
          <p:cNvPicPr/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30884" y="0"/>
            <a:ext cx="3522497" cy="3429001"/>
          </a:xfrm>
          <a:prstGeom prst="rect">
            <a:avLst/>
          </a:prstGeom>
          <a:noFill/>
          <a:ln>
            <a:noFill/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0191CA95-4A24-4111-8284-29232E0CF940}"/>
              </a:ext>
            </a:extLst>
          </p:cNvPr>
          <p:cNvPicPr/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5280" y="3158124"/>
            <a:ext cx="3471798" cy="3428999"/>
          </a:xfrm>
          <a:prstGeom prst="rect">
            <a:avLst/>
          </a:prstGeom>
          <a:noFill/>
          <a:ln>
            <a:noFill/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DC5FFB00-B5AD-4B29-8F0B-DD08F1FC88EA}"/>
              </a:ext>
            </a:extLst>
          </p:cNvPr>
          <p:cNvSpPr txBox="1"/>
          <p:nvPr/>
        </p:nvSpPr>
        <p:spPr>
          <a:xfrm>
            <a:off x="633644" y="6529031"/>
            <a:ext cx="25006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21</a:t>
            </a:r>
          </a:p>
        </p:txBody>
      </p:sp>
    </p:spTree>
    <p:extLst>
      <p:ext uri="{BB962C8B-B14F-4D97-AF65-F5344CB8AC3E}">
        <p14:creationId xmlns:p14="http://schemas.microsoft.com/office/powerpoint/2010/main" val="9310436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2</TotalTime>
  <Words>26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rivatsan, Eri S. (he/him/his)</dc:creator>
  <cp:lastModifiedBy>Srivatsan, Eri S. (he/him/his)</cp:lastModifiedBy>
  <cp:revision>20</cp:revision>
  <dcterms:created xsi:type="dcterms:W3CDTF">2024-02-09T21:19:49Z</dcterms:created>
  <dcterms:modified xsi:type="dcterms:W3CDTF">2024-02-09T22:52:26Z</dcterms:modified>
</cp:coreProperties>
</file>